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authors.xml" ContentType="application/vnd.ms-powerpoint.author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10"/>
  </p:notesMasterIdLst>
  <p:sldIdLst>
    <p:sldId id="263" r:id="rId5"/>
    <p:sldId id="259" r:id="rId6"/>
    <p:sldId id="261" r:id="rId7"/>
    <p:sldId id="260" r:id="rId8"/>
    <p:sldId id="262" r:id="rId9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CEB7B2-58E3-2D94-3DCC-1AE0A536E483}" name="Bente Frimodt-Moller" initials="BF" userId="S::frimodt-moller_bente@lilly.com::2e90a1f6-b6e3-4863-8808-7b2908451fb4" providerId="AD"/>
  <p188:author id="{62C8EBD3-6285-0CF5-8205-353CC37B87F6}" name="Mark Steven Leusch" initials="MSL" userId="S::leusch_mark@lilly.com::1b1bc71e-843b-4f96-a0a5-0b8629e5918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7B64648-5A70-EF7F-9484-7DDE907CDF3F}" v="5" dt="2023-05-22T07:06:15.301"/>
    <p1510:client id="{C17BFE46-9C81-4D83-9BFD-742C23E73986}" v="1" dt="2023-06-14T07:40:58.72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61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17" Type="http://schemas.microsoft.com/office/2018/10/relationships/authors" Target="author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23DF77-CDA0-4E10-AE89-8C8AA12F7FD7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7AC3C3-1A3C-43BD-A5A3-8E7183C783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98643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1AF239-AE12-467C-BE00-C36651128E3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11250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1AF239-AE12-467C-BE00-C36651128E3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90705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1AF239-AE12-467C-BE00-C36651128E36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11800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1AF239-AE12-467C-BE00-C36651128E36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90866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9741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3202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5851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1327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342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8285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0326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8282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417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0976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7071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4BF0D2-D442-452B-A334-8385537641C5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DACE1-B370-4C72-9310-D1F66EF4E0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4477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5.emf"/><Relationship Id="rId4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7" Type="http://schemas.openxmlformats.org/officeDocument/2006/relationships/image" Target="../media/image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7.emf"/><Relationship Id="rId4" Type="http://schemas.openxmlformats.org/officeDocument/2006/relationships/oleObject" Target="../embeddings/oleObject6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7" Type="http://schemas.openxmlformats.org/officeDocument/2006/relationships/image" Target="../media/image1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9.emf"/><Relationship Id="rId4" Type="http://schemas.openxmlformats.org/officeDocument/2006/relationships/oleObject" Target="../embeddings/oleObject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1FC3A4F-ECC3-F523-6D1C-5B591AA6C8D1}"/>
              </a:ext>
            </a:extLst>
          </p:cNvPr>
          <p:cNvSpPr txBox="1"/>
          <p:nvPr/>
        </p:nvSpPr>
        <p:spPr>
          <a:xfrm>
            <a:off x="638003" y="466582"/>
            <a:ext cx="1358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1a.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2819D943-16D2-6EC0-153D-393F77BA55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34817" y="1336592"/>
            <a:ext cx="4903416" cy="3787669"/>
          </a:xfrm>
          <a:prstGeom prst="rect">
            <a:avLst/>
          </a:prstGeom>
        </p:spPr>
      </p:pic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57553EA2-3531-76E0-706C-C95CEC86DD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898598"/>
              </p:ext>
            </p:extLst>
          </p:nvPr>
        </p:nvGraphicFramePr>
        <p:xfrm>
          <a:off x="4883395" y="1300378"/>
          <a:ext cx="4945280" cy="38238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7" r:id="rId4" imgW="3807956" imgH="2944126" progId="Prism7.Document">
                  <p:embed/>
                </p:oleObj>
              </mc:Choice>
              <mc:Fallback>
                <p:oleObj name="Prism 7" r:id="rId4" imgW="3807956" imgH="2944126" progId="Prism7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57553EA2-3531-76E0-706C-C95CEC86DD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83395" y="1300378"/>
                        <a:ext cx="4945280" cy="38238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9D5EA64-B7B9-61FD-B843-C391ED23A515}"/>
              </a:ext>
            </a:extLst>
          </p:cNvPr>
          <p:cNvSpPr txBox="1"/>
          <p:nvPr/>
        </p:nvSpPr>
        <p:spPr>
          <a:xfrm>
            <a:off x="8501270" y="3151251"/>
            <a:ext cx="8327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01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A651E4E-3E10-7772-A059-0BD0DAD71CD6}"/>
              </a:ext>
            </a:extLst>
          </p:cNvPr>
          <p:cNvSpPr txBox="1"/>
          <p:nvPr/>
        </p:nvSpPr>
        <p:spPr>
          <a:xfrm>
            <a:off x="3466134" y="3151252"/>
            <a:ext cx="8397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22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表 4">
            <a:extLst>
              <a:ext uri="{FF2B5EF4-FFF2-40B4-BE49-F238E27FC236}">
                <a16:creationId xmlns:a16="http://schemas.microsoft.com/office/drawing/2014/main" id="{547BB2A5-7947-28CE-AA3A-866EFFBDD8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6895064"/>
              </p:ext>
            </p:extLst>
          </p:nvPr>
        </p:nvGraphicFramePr>
        <p:xfrm>
          <a:off x="638003" y="5024904"/>
          <a:ext cx="3599019" cy="13030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72969">
                  <a:extLst>
                    <a:ext uri="{9D8B030D-6E8A-4147-A177-3AD203B41FA5}">
                      <a16:colId xmlns:a16="http://schemas.microsoft.com/office/drawing/2014/main" val="1512944701"/>
                    </a:ext>
                  </a:extLst>
                </a:gridCol>
                <a:gridCol w="1102787">
                  <a:extLst>
                    <a:ext uri="{9D8B030D-6E8A-4147-A177-3AD203B41FA5}">
                      <a16:colId xmlns:a16="http://schemas.microsoft.com/office/drawing/2014/main" val="4207086872"/>
                    </a:ext>
                  </a:extLst>
                </a:gridCol>
                <a:gridCol w="923263">
                  <a:extLst>
                    <a:ext uri="{9D8B030D-6E8A-4147-A177-3AD203B41FA5}">
                      <a16:colId xmlns:a16="http://schemas.microsoft.com/office/drawing/2014/main" val="2636817431"/>
                    </a:ext>
                  </a:extLst>
                </a:gridCol>
              </a:tblGrid>
              <a:tr h="398203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+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23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-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5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437024"/>
                  </a:ext>
                </a:extLst>
              </a:tr>
              <a:tr h="39820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 mo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9-4.8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7-4.0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0847840"/>
                  </a:ext>
                </a:extLst>
              </a:tr>
              <a:tr h="39820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vs PEG-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58-1.03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9566447"/>
                  </a:ext>
                </a:extLst>
              </a:tr>
            </a:tbl>
          </a:graphicData>
        </a:graphic>
      </p:graphicFrame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65BBBAD4-A77C-3630-78DE-13DE9E4DCA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0944637"/>
              </p:ext>
            </p:extLst>
          </p:nvPr>
        </p:nvGraphicFramePr>
        <p:xfrm>
          <a:off x="5694516" y="5024904"/>
          <a:ext cx="3558125" cy="13030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76157">
                  <a:extLst>
                    <a:ext uri="{9D8B030D-6E8A-4147-A177-3AD203B41FA5}">
                      <a16:colId xmlns:a16="http://schemas.microsoft.com/office/drawing/2014/main" val="1512944701"/>
                    </a:ext>
                  </a:extLst>
                </a:gridCol>
                <a:gridCol w="1169194">
                  <a:extLst>
                    <a:ext uri="{9D8B030D-6E8A-4147-A177-3AD203B41FA5}">
                      <a16:colId xmlns:a16="http://schemas.microsoft.com/office/drawing/2014/main" val="4207086872"/>
                    </a:ext>
                  </a:extLst>
                </a:gridCol>
                <a:gridCol w="912774">
                  <a:extLst>
                    <a:ext uri="{9D8B030D-6E8A-4147-A177-3AD203B41FA5}">
                      <a16:colId xmlns:a16="http://schemas.microsoft.com/office/drawing/2014/main" val="2636817431"/>
                    </a:ext>
                  </a:extLst>
                </a:gridCol>
              </a:tblGrid>
              <a:tr h="384778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+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23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-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5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437024"/>
                  </a:ext>
                </a:extLst>
              </a:tr>
              <a:tr h="38477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S, mo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1.8-15.8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7.2-10.1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0847840"/>
                  </a:ext>
                </a:extLst>
              </a:tr>
              <a:tr h="38477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vs PEG-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44-0.90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9566447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1FC3A4F-ECC3-F523-6D1C-5B591AA6C8D1}"/>
              </a:ext>
            </a:extLst>
          </p:cNvPr>
          <p:cNvSpPr txBox="1"/>
          <p:nvPr/>
        </p:nvSpPr>
        <p:spPr>
          <a:xfrm>
            <a:off x="5594627" y="466582"/>
            <a:ext cx="13584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1b.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60813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AB59009B-AFA0-1E58-A3FE-3F965BDF37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4748648"/>
              </p:ext>
            </p:extLst>
          </p:nvPr>
        </p:nvGraphicFramePr>
        <p:xfrm>
          <a:off x="-183805" y="1350155"/>
          <a:ext cx="4936874" cy="38173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7" r:id="rId4" imgW="3807956" imgH="2944126" progId="Prism7.Document">
                  <p:embed/>
                </p:oleObj>
              </mc:Choice>
              <mc:Fallback>
                <p:oleObj name="Prism 7" r:id="rId4" imgW="3807956" imgH="2944126" progId="Prism7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AB59009B-AFA0-1E58-A3FE-3F965BDF37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183805" y="1350155"/>
                        <a:ext cx="4936874" cy="38173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EEFD89E-2B4A-C083-6636-0C5E92DE14FA}"/>
              </a:ext>
            </a:extLst>
          </p:cNvPr>
          <p:cNvSpPr txBox="1"/>
          <p:nvPr/>
        </p:nvSpPr>
        <p:spPr>
          <a:xfrm>
            <a:off x="578396" y="442492"/>
            <a:ext cx="15451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2a.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DDE9188-1C40-01CB-4B13-27DEFA6BB3DD}"/>
              </a:ext>
            </a:extLst>
          </p:cNvPr>
          <p:cNvSpPr txBox="1"/>
          <p:nvPr/>
        </p:nvSpPr>
        <p:spPr>
          <a:xfrm>
            <a:off x="3443444" y="3132116"/>
            <a:ext cx="93843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69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0007595-14A8-E8EA-B8B2-633B4CCEEF95}"/>
              </a:ext>
            </a:extLst>
          </p:cNvPr>
          <p:cNvSpPr txBox="1"/>
          <p:nvPr/>
        </p:nvSpPr>
        <p:spPr>
          <a:xfrm>
            <a:off x="3957928" y="6451845"/>
            <a:ext cx="23385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denocarcinoma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5A91F7B7-3DC0-A60E-2BE9-2F32EAE29B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1130023"/>
              </p:ext>
            </p:extLst>
          </p:nvPr>
        </p:nvGraphicFramePr>
        <p:xfrm>
          <a:off x="4919192" y="1400864"/>
          <a:ext cx="4890806" cy="37666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7" r:id="rId6" imgW="3837246" imgH="2954704" progId="Prism7.Document">
                  <p:embed/>
                </p:oleObj>
              </mc:Choice>
              <mc:Fallback>
                <p:oleObj name="Prism 7" r:id="rId6" imgW="3837246" imgH="2954704" progId="Prism7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5A91F7B7-3DC0-A60E-2BE9-2F32EAE29B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919192" y="1400864"/>
                        <a:ext cx="4890806" cy="37666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E64B951-5E9E-DDB2-FFCC-E5C440218925}"/>
              </a:ext>
            </a:extLst>
          </p:cNvPr>
          <p:cNvSpPr txBox="1"/>
          <p:nvPr/>
        </p:nvSpPr>
        <p:spPr>
          <a:xfrm>
            <a:off x="8481922" y="3150222"/>
            <a:ext cx="10061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12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表 4">
            <a:extLst>
              <a:ext uri="{FF2B5EF4-FFF2-40B4-BE49-F238E27FC236}">
                <a16:creationId xmlns:a16="http://schemas.microsoft.com/office/drawing/2014/main" id="{D242A7D7-F53C-EADE-747F-065FECDA0D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0584022"/>
              </p:ext>
            </p:extLst>
          </p:nvPr>
        </p:nvGraphicFramePr>
        <p:xfrm>
          <a:off x="660903" y="5105648"/>
          <a:ext cx="3603279" cy="12041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24103">
                  <a:extLst>
                    <a:ext uri="{9D8B030D-6E8A-4147-A177-3AD203B41FA5}">
                      <a16:colId xmlns:a16="http://schemas.microsoft.com/office/drawing/2014/main" val="1512944701"/>
                    </a:ext>
                  </a:extLst>
                </a:gridCol>
                <a:gridCol w="1153764">
                  <a:extLst>
                    <a:ext uri="{9D8B030D-6E8A-4147-A177-3AD203B41FA5}">
                      <a16:colId xmlns:a16="http://schemas.microsoft.com/office/drawing/2014/main" val="4207086872"/>
                    </a:ext>
                  </a:extLst>
                </a:gridCol>
                <a:gridCol w="825412">
                  <a:extLst>
                    <a:ext uri="{9D8B030D-6E8A-4147-A177-3AD203B41FA5}">
                      <a16:colId xmlns:a16="http://schemas.microsoft.com/office/drawing/2014/main" val="2636817431"/>
                    </a:ext>
                  </a:extLst>
                </a:gridCol>
              </a:tblGrid>
              <a:tr h="367317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+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72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-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7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437024"/>
                  </a:ext>
                </a:extLst>
              </a:tr>
              <a:tr h="19995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 mo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7-5.5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8-4.2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0847840"/>
                  </a:ext>
                </a:extLst>
              </a:tr>
              <a:tr h="36731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vs PEG-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49-1.17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9566447"/>
                  </a:ext>
                </a:extLst>
              </a:tr>
            </a:tbl>
          </a:graphicData>
        </a:graphic>
      </p:graphicFrame>
      <p:graphicFrame>
        <p:nvGraphicFramePr>
          <p:cNvPr id="10" name="表 4">
            <a:extLst>
              <a:ext uri="{FF2B5EF4-FFF2-40B4-BE49-F238E27FC236}">
                <a16:creationId xmlns:a16="http://schemas.microsoft.com/office/drawing/2014/main" id="{29303415-30FB-1B96-D3E4-E64C96AD5A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9814760"/>
              </p:ext>
            </p:extLst>
          </p:nvPr>
        </p:nvGraphicFramePr>
        <p:xfrm>
          <a:off x="5721789" y="5114441"/>
          <a:ext cx="3548961" cy="12041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41355">
                  <a:extLst>
                    <a:ext uri="{9D8B030D-6E8A-4147-A177-3AD203B41FA5}">
                      <a16:colId xmlns:a16="http://schemas.microsoft.com/office/drawing/2014/main" val="1512944701"/>
                    </a:ext>
                  </a:extLst>
                </a:gridCol>
                <a:gridCol w="1094636">
                  <a:extLst>
                    <a:ext uri="{9D8B030D-6E8A-4147-A177-3AD203B41FA5}">
                      <a16:colId xmlns:a16="http://schemas.microsoft.com/office/drawing/2014/main" val="4207086872"/>
                    </a:ext>
                  </a:extLst>
                </a:gridCol>
                <a:gridCol w="812970">
                  <a:extLst>
                    <a:ext uri="{9D8B030D-6E8A-4147-A177-3AD203B41FA5}">
                      <a16:colId xmlns:a16="http://schemas.microsoft.com/office/drawing/2014/main" val="2636817431"/>
                    </a:ext>
                  </a:extLst>
                </a:gridCol>
              </a:tblGrid>
              <a:tr h="376074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+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72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-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7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437024"/>
                  </a:ext>
                </a:extLst>
              </a:tr>
              <a:tr h="20471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S, mo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6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2.6-16.6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6-13.2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0847840"/>
                  </a:ext>
                </a:extLst>
              </a:tr>
              <a:tr h="37607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vs PEG-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34-0.99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9566447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EEFD89E-2B4A-C083-6636-0C5E92DE14FA}"/>
              </a:ext>
            </a:extLst>
          </p:cNvPr>
          <p:cNvSpPr txBox="1"/>
          <p:nvPr/>
        </p:nvSpPr>
        <p:spPr>
          <a:xfrm>
            <a:off x="5601056" y="442492"/>
            <a:ext cx="15451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2b.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69496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オブジェクト 12">
            <a:extLst>
              <a:ext uri="{FF2B5EF4-FFF2-40B4-BE49-F238E27FC236}">
                <a16:creationId xmlns:a16="http://schemas.microsoft.com/office/drawing/2014/main" id="{003BF06F-1330-2B32-681A-76B9BF1E52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5067202"/>
              </p:ext>
            </p:extLst>
          </p:nvPr>
        </p:nvGraphicFramePr>
        <p:xfrm>
          <a:off x="0" y="1448596"/>
          <a:ext cx="4734962" cy="36612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0" name="Prism 7" r:id="rId4" imgW="3807956" imgH="2944126" progId="Prism7.Document">
                  <p:embed/>
                </p:oleObj>
              </mc:Choice>
              <mc:Fallback>
                <p:oleObj name="Prism 7" r:id="rId4" imgW="3807956" imgH="2944126" progId="Prism7.Document">
                  <p:embed/>
                  <p:pic>
                    <p:nvPicPr>
                      <p:cNvPr id="13" name="オブジェクト 12">
                        <a:extLst>
                          <a:ext uri="{FF2B5EF4-FFF2-40B4-BE49-F238E27FC236}">
                            <a16:creationId xmlns:a16="http://schemas.microsoft.com/office/drawing/2014/main" id="{003BF06F-1330-2B32-681A-76B9BF1E52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1448596"/>
                        <a:ext cx="4734962" cy="36612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EEFD89E-2B4A-C083-6636-0C5E92DE14FA}"/>
              </a:ext>
            </a:extLst>
          </p:cNvPr>
          <p:cNvSpPr txBox="1"/>
          <p:nvPr/>
        </p:nvSpPr>
        <p:spPr>
          <a:xfrm>
            <a:off x="551235" y="449064"/>
            <a:ext cx="13862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3a.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3B4632D-5CE8-7DA6-6CD1-23377AC7AC01}"/>
              </a:ext>
            </a:extLst>
          </p:cNvPr>
          <p:cNvSpPr txBox="1"/>
          <p:nvPr/>
        </p:nvSpPr>
        <p:spPr>
          <a:xfrm>
            <a:off x="3480879" y="3143441"/>
            <a:ext cx="93286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&lt;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14266DCD-CFD5-D2BA-73B6-EC8DD02CFD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39112670"/>
              </p:ext>
            </p:extLst>
          </p:nvPr>
        </p:nvGraphicFramePr>
        <p:xfrm>
          <a:off x="5003885" y="1455395"/>
          <a:ext cx="4764803" cy="36843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1" name="Prism 7" r:id="rId6" imgW="3807956" imgH="2944126" progId="Prism7.Document">
                  <p:embed/>
                </p:oleObj>
              </mc:Choice>
              <mc:Fallback>
                <p:oleObj name="Prism 7" r:id="rId6" imgW="3807956" imgH="2944126" progId="Prism7.Document">
                  <p:embed/>
                  <p:pic>
                    <p:nvPicPr>
                      <p:cNvPr id="11" name="オブジェクト 10">
                        <a:extLst>
                          <a:ext uri="{FF2B5EF4-FFF2-40B4-BE49-F238E27FC236}">
                            <a16:creationId xmlns:a16="http://schemas.microsoft.com/office/drawing/2014/main" id="{14266DCD-CFD5-D2BA-73B6-EC8DD02CFD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003885" y="1455395"/>
                        <a:ext cx="4764803" cy="36843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E942745-4727-4FDB-387D-B4ADD0D0F6E2}"/>
              </a:ext>
            </a:extLst>
          </p:cNvPr>
          <p:cNvSpPr txBox="1"/>
          <p:nvPr/>
        </p:nvSpPr>
        <p:spPr>
          <a:xfrm>
            <a:off x="8516084" y="3134388"/>
            <a:ext cx="10081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11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4DA4B7B-4ED0-6E6F-B2F7-03C628C41433}"/>
              </a:ext>
            </a:extLst>
          </p:cNvPr>
          <p:cNvSpPr txBox="1"/>
          <p:nvPr/>
        </p:nvSpPr>
        <p:spPr>
          <a:xfrm>
            <a:off x="3663794" y="6439468"/>
            <a:ext cx="26801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Non-adenocarcinoma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表 4">
            <a:extLst>
              <a:ext uri="{FF2B5EF4-FFF2-40B4-BE49-F238E27FC236}">
                <a16:creationId xmlns:a16="http://schemas.microsoft.com/office/drawing/2014/main" id="{5C4FB65E-B36C-4F8A-3656-4DC62C54B5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4332344"/>
              </p:ext>
            </p:extLst>
          </p:nvPr>
        </p:nvGraphicFramePr>
        <p:xfrm>
          <a:off x="660551" y="5120725"/>
          <a:ext cx="3567416" cy="12041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49892">
                  <a:extLst>
                    <a:ext uri="{9D8B030D-6E8A-4147-A177-3AD203B41FA5}">
                      <a16:colId xmlns:a16="http://schemas.microsoft.com/office/drawing/2014/main" val="1512944701"/>
                    </a:ext>
                  </a:extLst>
                </a:gridCol>
                <a:gridCol w="1100327">
                  <a:extLst>
                    <a:ext uri="{9D8B030D-6E8A-4147-A177-3AD203B41FA5}">
                      <a16:colId xmlns:a16="http://schemas.microsoft.com/office/drawing/2014/main" val="4207086872"/>
                    </a:ext>
                  </a:extLst>
                </a:gridCol>
                <a:gridCol w="817197">
                  <a:extLst>
                    <a:ext uri="{9D8B030D-6E8A-4147-A177-3AD203B41FA5}">
                      <a16:colId xmlns:a16="http://schemas.microsoft.com/office/drawing/2014/main" val="2636817431"/>
                    </a:ext>
                  </a:extLst>
                </a:gridCol>
              </a:tblGrid>
              <a:tr h="370379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+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5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-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4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437024"/>
                  </a:ext>
                </a:extLst>
              </a:tr>
              <a:tr h="20161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 mo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6-4.4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.3-2.4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0847840"/>
                  </a:ext>
                </a:extLst>
              </a:tr>
              <a:tr h="37037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vs PEG-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31-0.98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9566447"/>
                  </a:ext>
                </a:extLst>
              </a:tr>
            </a:tbl>
          </a:graphicData>
        </a:graphic>
      </p:graphicFrame>
      <p:graphicFrame>
        <p:nvGraphicFramePr>
          <p:cNvPr id="16" name="表 4">
            <a:extLst>
              <a:ext uri="{FF2B5EF4-FFF2-40B4-BE49-F238E27FC236}">
                <a16:creationId xmlns:a16="http://schemas.microsoft.com/office/drawing/2014/main" id="{7FB6CD52-B2A4-B9D6-DE2D-B080569F19C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8517583"/>
              </p:ext>
            </p:extLst>
          </p:nvPr>
        </p:nvGraphicFramePr>
        <p:xfrm>
          <a:off x="5690123" y="5120729"/>
          <a:ext cx="3571571" cy="12041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51814">
                  <a:extLst>
                    <a:ext uri="{9D8B030D-6E8A-4147-A177-3AD203B41FA5}">
                      <a16:colId xmlns:a16="http://schemas.microsoft.com/office/drawing/2014/main" val="1512944701"/>
                    </a:ext>
                  </a:extLst>
                </a:gridCol>
                <a:gridCol w="1101608">
                  <a:extLst>
                    <a:ext uri="{9D8B030D-6E8A-4147-A177-3AD203B41FA5}">
                      <a16:colId xmlns:a16="http://schemas.microsoft.com/office/drawing/2014/main" val="4207086872"/>
                    </a:ext>
                  </a:extLst>
                </a:gridCol>
                <a:gridCol w="818149">
                  <a:extLst>
                    <a:ext uri="{9D8B030D-6E8A-4147-A177-3AD203B41FA5}">
                      <a16:colId xmlns:a16="http://schemas.microsoft.com/office/drawing/2014/main" val="2636817431"/>
                    </a:ext>
                  </a:extLst>
                </a:gridCol>
              </a:tblGrid>
              <a:tr h="386426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+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5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-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4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437024"/>
                  </a:ext>
                </a:extLst>
              </a:tr>
              <a:tr h="17443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S, mo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7.2-12.4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7-12.4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0847840"/>
                  </a:ext>
                </a:extLst>
              </a:tr>
              <a:tr h="38642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vs PEG-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41-1.64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9566447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EEFD89E-2B4A-C083-6636-0C5E92DE14FA}"/>
              </a:ext>
            </a:extLst>
          </p:cNvPr>
          <p:cNvSpPr txBox="1"/>
          <p:nvPr/>
        </p:nvSpPr>
        <p:spPr>
          <a:xfrm>
            <a:off x="5592509" y="459091"/>
            <a:ext cx="13862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3b.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81054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208DBC87-8124-74B7-5D5D-F1F54CF72E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1806900"/>
              </p:ext>
            </p:extLst>
          </p:nvPr>
        </p:nvGraphicFramePr>
        <p:xfrm>
          <a:off x="4985012" y="1425496"/>
          <a:ext cx="4810838" cy="37199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Prism 7" r:id="rId4" imgW="3807956" imgH="2944126" progId="Prism7.Document">
                  <p:embed/>
                </p:oleObj>
              </mc:Choice>
              <mc:Fallback>
                <p:oleObj name="Prism 7" r:id="rId4" imgW="3807956" imgH="2944126" progId="Prism7.Document">
                  <p:embed/>
                  <p:pic>
                    <p:nvPicPr>
                      <p:cNvPr id="10" name="オブジェクト 9">
                        <a:extLst>
                          <a:ext uri="{FF2B5EF4-FFF2-40B4-BE49-F238E27FC236}">
                            <a16:creationId xmlns:a16="http://schemas.microsoft.com/office/drawing/2014/main" id="{208DBC87-8124-74B7-5D5D-F1F54CF72E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985012" y="1425496"/>
                        <a:ext cx="4810838" cy="37199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ADED1B82-2D91-8FB0-48D4-A9FA1A9C83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7457633"/>
              </p:ext>
            </p:extLst>
          </p:nvPr>
        </p:nvGraphicFramePr>
        <p:xfrm>
          <a:off x="-44553" y="1458083"/>
          <a:ext cx="4806675" cy="37167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5" name="Prism 7" r:id="rId6" imgW="3807956" imgH="2944126" progId="Prism7.Document">
                  <p:embed/>
                </p:oleObj>
              </mc:Choice>
              <mc:Fallback>
                <p:oleObj name="Prism 7" r:id="rId6" imgW="3807956" imgH="2944126" progId="Prism7.Document">
                  <p:embed/>
                  <p:pic>
                    <p:nvPicPr>
                      <p:cNvPr id="8" name="オブジェクト 7">
                        <a:extLst>
                          <a:ext uri="{FF2B5EF4-FFF2-40B4-BE49-F238E27FC236}">
                            <a16:creationId xmlns:a16="http://schemas.microsoft.com/office/drawing/2014/main" id="{ADED1B82-2D91-8FB0-48D4-A9FA1A9C83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44553" y="1458083"/>
                        <a:ext cx="4806675" cy="37167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EEFD89E-2B4A-C083-6636-0C5E92DE14FA}"/>
              </a:ext>
            </a:extLst>
          </p:cNvPr>
          <p:cNvSpPr txBox="1"/>
          <p:nvPr/>
        </p:nvSpPr>
        <p:spPr>
          <a:xfrm>
            <a:off x="544825" y="439030"/>
            <a:ext cx="15061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4a.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DDE9188-1C40-01CB-4B13-27DEFA6BB3DD}"/>
              </a:ext>
            </a:extLst>
          </p:cNvPr>
          <p:cNvSpPr txBox="1"/>
          <p:nvPr/>
        </p:nvSpPr>
        <p:spPr>
          <a:xfrm>
            <a:off x="3442249" y="3144441"/>
            <a:ext cx="90966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222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0007595-14A8-E8EA-B8B2-633B4CCEEF95}"/>
              </a:ext>
            </a:extLst>
          </p:cNvPr>
          <p:cNvSpPr txBox="1"/>
          <p:nvPr/>
        </p:nvSpPr>
        <p:spPr>
          <a:xfrm>
            <a:off x="3844482" y="6412676"/>
            <a:ext cx="22810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denocarcinoma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E64B951-5E9E-DDB2-FFCC-E5C440218925}"/>
              </a:ext>
            </a:extLst>
          </p:cNvPr>
          <p:cNvSpPr txBox="1"/>
          <p:nvPr/>
        </p:nvSpPr>
        <p:spPr>
          <a:xfrm>
            <a:off x="8501959" y="3131570"/>
            <a:ext cx="8673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2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 4">
            <a:extLst>
              <a:ext uri="{FF2B5EF4-FFF2-40B4-BE49-F238E27FC236}">
                <a16:creationId xmlns:a16="http://schemas.microsoft.com/office/drawing/2014/main" id="{D92B51DC-E09F-041A-33F0-0DF80D3A2C6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1342177"/>
              </p:ext>
            </p:extLst>
          </p:nvPr>
        </p:nvGraphicFramePr>
        <p:xfrm>
          <a:off x="640832" y="5116073"/>
          <a:ext cx="3596190" cy="12041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63200">
                  <a:extLst>
                    <a:ext uri="{9D8B030D-6E8A-4147-A177-3AD203B41FA5}">
                      <a16:colId xmlns:a16="http://schemas.microsoft.com/office/drawing/2014/main" val="1512944701"/>
                    </a:ext>
                  </a:extLst>
                </a:gridCol>
                <a:gridCol w="1109202">
                  <a:extLst>
                    <a:ext uri="{9D8B030D-6E8A-4147-A177-3AD203B41FA5}">
                      <a16:colId xmlns:a16="http://schemas.microsoft.com/office/drawing/2014/main" val="4207086872"/>
                    </a:ext>
                  </a:extLst>
                </a:gridCol>
                <a:gridCol w="823788">
                  <a:extLst>
                    <a:ext uri="{9D8B030D-6E8A-4147-A177-3AD203B41FA5}">
                      <a16:colId xmlns:a16="http://schemas.microsoft.com/office/drawing/2014/main" val="2636817431"/>
                    </a:ext>
                  </a:extLst>
                </a:gridCol>
              </a:tblGrid>
              <a:tr h="310698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+</a:t>
                      </a:r>
                    </a:p>
                    <a:p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57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-</a:t>
                      </a:r>
                    </a:p>
                    <a:p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2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437024"/>
                  </a:ext>
                </a:extLst>
              </a:tr>
              <a:tr h="1846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 mo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7-5.5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7-5.2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0847840"/>
                  </a:ext>
                </a:extLst>
              </a:tr>
              <a:tr h="31069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vs PEG-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60-1.25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9566447"/>
                  </a:ext>
                </a:extLst>
              </a:tr>
            </a:tbl>
          </a:graphicData>
        </a:graphic>
      </p:graphicFrame>
      <p:graphicFrame>
        <p:nvGraphicFramePr>
          <p:cNvPr id="6" name="表 4">
            <a:extLst>
              <a:ext uri="{FF2B5EF4-FFF2-40B4-BE49-F238E27FC236}">
                <a16:creationId xmlns:a16="http://schemas.microsoft.com/office/drawing/2014/main" id="{45EAFA65-FDBB-DE4B-5677-6D3B60FAE6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4749169"/>
              </p:ext>
            </p:extLst>
          </p:nvPr>
        </p:nvGraphicFramePr>
        <p:xfrm>
          <a:off x="5700235" y="5116069"/>
          <a:ext cx="3570515" cy="12041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51325">
                  <a:extLst>
                    <a:ext uri="{9D8B030D-6E8A-4147-A177-3AD203B41FA5}">
                      <a16:colId xmlns:a16="http://schemas.microsoft.com/office/drawing/2014/main" val="1512944701"/>
                    </a:ext>
                  </a:extLst>
                </a:gridCol>
                <a:gridCol w="1101283">
                  <a:extLst>
                    <a:ext uri="{9D8B030D-6E8A-4147-A177-3AD203B41FA5}">
                      <a16:colId xmlns:a16="http://schemas.microsoft.com/office/drawing/2014/main" val="4207086872"/>
                    </a:ext>
                  </a:extLst>
                </a:gridCol>
                <a:gridCol w="817907">
                  <a:extLst>
                    <a:ext uri="{9D8B030D-6E8A-4147-A177-3AD203B41FA5}">
                      <a16:colId xmlns:a16="http://schemas.microsoft.com/office/drawing/2014/main" val="2636817431"/>
                    </a:ext>
                  </a:extLst>
                </a:gridCol>
              </a:tblGrid>
              <a:tr h="363740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+</a:t>
                      </a:r>
                    </a:p>
                    <a:p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57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-</a:t>
                      </a:r>
                    </a:p>
                    <a:p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2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437024"/>
                  </a:ext>
                </a:extLst>
              </a:tr>
              <a:tr h="19800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S, mo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9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3.3-16.5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6.1-13.8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0847840"/>
                  </a:ext>
                </a:extLst>
              </a:tr>
              <a:tr h="3637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vs PEG-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42-1.06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9566447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EEFD89E-2B4A-C083-6636-0C5E92DE14FA}"/>
              </a:ext>
            </a:extLst>
          </p:cNvPr>
          <p:cNvSpPr txBox="1"/>
          <p:nvPr/>
        </p:nvSpPr>
        <p:spPr>
          <a:xfrm>
            <a:off x="5584956" y="439030"/>
            <a:ext cx="13862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4b.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30224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オブジェクト 15">
            <a:extLst>
              <a:ext uri="{FF2B5EF4-FFF2-40B4-BE49-F238E27FC236}">
                <a16:creationId xmlns:a16="http://schemas.microsoft.com/office/drawing/2014/main" id="{FA137018-77BE-A465-A753-09828FF6C4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4532277"/>
              </p:ext>
            </p:extLst>
          </p:nvPr>
        </p:nvGraphicFramePr>
        <p:xfrm>
          <a:off x="4890447" y="1348798"/>
          <a:ext cx="4878241" cy="37720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8" name="Prism 7" r:id="rId4" imgW="3807956" imgH="2944126" progId="Prism7.Document">
                  <p:embed/>
                </p:oleObj>
              </mc:Choice>
              <mc:Fallback>
                <p:oleObj name="Prism 7" r:id="rId4" imgW="3807956" imgH="2944126" progId="Prism7.Document">
                  <p:embed/>
                  <p:pic>
                    <p:nvPicPr>
                      <p:cNvPr id="16" name="オブジェクト 15">
                        <a:extLst>
                          <a:ext uri="{FF2B5EF4-FFF2-40B4-BE49-F238E27FC236}">
                            <a16:creationId xmlns:a16="http://schemas.microsoft.com/office/drawing/2014/main" id="{FA137018-77BE-A465-A753-09828FF6C4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90447" y="1348798"/>
                        <a:ext cx="4878241" cy="37720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オブジェクト 14">
            <a:extLst>
              <a:ext uri="{FF2B5EF4-FFF2-40B4-BE49-F238E27FC236}">
                <a16:creationId xmlns:a16="http://schemas.microsoft.com/office/drawing/2014/main" id="{F9C88129-8D00-E7DD-37B9-41EA7ABAB5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3311812"/>
              </p:ext>
            </p:extLst>
          </p:nvPr>
        </p:nvGraphicFramePr>
        <p:xfrm>
          <a:off x="-41685" y="1403116"/>
          <a:ext cx="4794754" cy="37074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9" name="Prism 7" r:id="rId6" imgW="3807956" imgH="2944126" progId="Prism7.Document">
                  <p:embed/>
                </p:oleObj>
              </mc:Choice>
              <mc:Fallback>
                <p:oleObj name="Prism 7" r:id="rId6" imgW="3807956" imgH="2944126" progId="Prism7.Document">
                  <p:embed/>
                  <p:pic>
                    <p:nvPicPr>
                      <p:cNvPr id="15" name="オブジェクト 14">
                        <a:extLst>
                          <a:ext uri="{FF2B5EF4-FFF2-40B4-BE49-F238E27FC236}">
                            <a16:creationId xmlns:a16="http://schemas.microsoft.com/office/drawing/2014/main" id="{F9C88129-8D00-E7DD-37B9-41EA7ABAB5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41685" y="1403116"/>
                        <a:ext cx="4794754" cy="37074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EEFD89E-2B4A-C083-6636-0C5E92DE14FA}"/>
              </a:ext>
            </a:extLst>
          </p:cNvPr>
          <p:cNvSpPr txBox="1"/>
          <p:nvPr/>
        </p:nvSpPr>
        <p:spPr>
          <a:xfrm>
            <a:off x="535339" y="450224"/>
            <a:ext cx="15966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5a.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3B4632D-5CE8-7DA6-6CD1-23377AC7AC01}"/>
              </a:ext>
            </a:extLst>
          </p:cNvPr>
          <p:cNvSpPr txBox="1"/>
          <p:nvPr/>
        </p:nvSpPr>
        <p:spPr>
          <a:xfrm>
            <a:off x="3464940" y="3157289"/>
            <a:ext cx="83159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14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E942745-4727-4FDB-387D-B4ADD0D0F6E2}"/>
              </a:ext>
            </a:extLst>
          </p:cNvPr>
          <p:cNvSpPr txBox="1"/>
          <p:nvPr/>
        </p:nvSpPr>
        <p:spPr>
          <a:xfrm>
            <a:off x="8506661" y="3157288"/>
            <a:ext cx="92704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19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4DA4B7B-4ED0-6E6F-B2F7-03C628C41433}"/>
              </a:ext>
            </a:extLst>
          </p:cNvPr>
          <p:cNvSpPr txBox="1"/>
          <p:nvPr/>
        </p:nvSpPr>
        <p:spPr>
          <a:xfrm>
            <a:off x="3550140" y="6476807"/>
            <a:ext cx="30726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Non-adenocarcinoma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表 4">
            <a:extLst>
              <a:ext uri="{FF2B5EF4-FFF2-40B4-BE49-F238E27FC236}">
                <a16:creationId xmlns:a16="http://schemas.microsoft.com/office/drawing/2014/main" id="{9FBEC63E-F23E-156E-B0E3-1D8897427F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9804925"/>
              </p:ext>
            </p:extLst>
          </p:nvPr>
        </p:nvGraphicFramePr>
        <p:xfrm>
          <a:off x="637717" y="5112368"/>
          <a:ext cx="3581197" cy="12041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56265">
                  <a:extLst>
                    <a:ext uri="{9D8B030D-6E8A-4147-A177-3AD203B41FA5}">
                      <a16:colId xmlns:a16="http://schemas.microsoft.com/office/drawing/2014/main" val="1512944701"/>
                    </a:ext>
                  </a:extLst>
                </a:gridCol>
                <a:gridCol w="1104578">
                  <a:extLst>
                    <a:ext uri="{9D8B030D-6E8A-4147-A177-3AD203B41FA5}">
                      <a16:colId xmlns:a16="http://schemas.microsoft.com/office/drawing/2014/main" val="4207086872"/>
                    </a:ext>
                  </a:extLst>
                </a:gridCol>
                <a:gridCol w="820354">
                  <a:extLst>
                    <a:ext uri="{9D8B030D-6E8A-4147-A177-3AD203B41FA5}">
                      <a16:colId xmlns:a16="http://schemas.microsoft.com/office/drawing/2014/main" val="2636817431"/>
                    </a:ext>
                  </a:extLst>
                </a:gridCol>
              </a:tblGrid>
              <a:tr h="330664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+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6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-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3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437024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 mo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5-4.5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.7-3.0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0847840"/>
                  </a:ext>
                </a:extLst>
              </a:tr>
              <a:tr h="3306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vs PEG-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39-1.02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9566447"/>
                  </a:ext>
                </a:extLst>
              </a:tr>
            </a:tbl>
          </a:graphicData>
        </a:graphic>
      </p:graphicFrame>
      <p:graphicFrame>
        <p:nvGraphicFramePr>
          <p:cNvPr id="13" name="表 4">
            <a:extLst>
              <a:ext uri="{FF2B5EF4-FFF2-40B4-BE49-F238E27FC236}">
                <a16:creationId xmlns:a16="http://schemas.microsoft.com/office/drawing/2014/main" id="{A04ADAA1-187F-BFF4-0BBE-2CE82F6793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2566066"/>
              </p:ext>
            </p:extLst>
          </p:nvPr>
        </p:nvGraphicFramePr>
        <p:xfrm>
          <a:off x="5660637" y="5121160"/>
          <a:ext cx="3610111" cy="12041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69637">
                  <a:extLst>
                    <a:ext uri="{9D8B030D-6E8A-4147-A177-3AD203B41FA5}">
                      <a16:colId xmlns:a16="http://schemas.microsoft.com/office/drawing/2014/main" val="1512944701"/>
                    </a:ext>
                  </a:extLst>
                </a:gridCol>
                <a:gridCol w="1113497">
                  <a:extLst>
                    <a:ext uri="{9D8B030D-6E8A-4147-A177-3AD203B41FA5}">
                      <a16:colId xmlns:a16="http://schemas.microsoft.com/office/drawing/2014/main" val="4207086872"/>
                    </a:ext>
                  </a:extLst>
                </a:gridCol>
                <a:gridCol w="826977">
                  <a:extLst>
                    <a:ext uri="{9D8B030D-6E8A-4147-A177-3AD203B41FA5}">
                      <a16:colId xmlns:a16="http://schemas.microsoft.com/office/drawing/2014/main" val="2636817431"/>
                    </a:ext>
                  </a:extLst>
                </a:gridCol>
              </a:tblGrid>
              <a:tr h="347854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+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6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G-</a:t>
                      </a:r>
                    </a:p>
                    <a:p>
                      <a:pPr algn="ctr"/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3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437024"/>
                  </a:ext>
                </a:extLst>
              </a:tr>
              <a:tr h="18935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S, mo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7.5-12.1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6-10.1)</a:t>
                      </a: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90847840"/>
                  </a:ext>
                </a:extLst>
              </a:tr>
              <a:tr h="34785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vs PEG-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42-1.30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609" marR="35609" marT="17804" marB="1780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9566447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EEFD89E-2B4A-C083-6636-0C5E92DE14FA}"/>
              </a:ext>
            </a:extLst>
          </p:cNvPr>
          <p:cNvSpPr txBox="1"/>
          <p:nvPr/>
        </p:nvSpPr>
        <p:spPr>
          <a:xfrm>
            <a:off x="5572211" y="448655"/>
            <a:ext cx="15966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5b.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9609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a3f52a8-2511-4fc2-82a5-d1d42080630f" xsi:nil="true"/>
    <lcf76f155ced4ddcb4097134ff3c332f xmlns="8439fbcf-6450-441b-9192-933f07ebae26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7D66063A5D03E42A12169524873DCDA" ma:contentTypeVersion="12" ma:contentTypeDescription="Create a new document." ma:contentTypeScope="" ma:versionID="c9abe1f291f8c0c52b28a4d59a28bffc">
  <xsd:schema xmlns:xsd="http://www.w3.org/2001/XMLSchema" xmlns:xs="http://www.w3.org/2001/XMLSchema" xmlns:p="http://schemas.microsoft.com/office/2006/metadata/properties" xmlns:ns2="8439fbcf-6450-441b-9192-933f07ebae26" xmlns:ns3="4a3f52a8-2511-4fc2-82a5-d1d42080630f" targetNamespace="http://schemas.microsoft.com/office/2006/metadata/properties" ma:root="true" ma:fieldsID="746d0166cbd9e0268b7bf8387d96ffa2" ns2:_="" ns3:_="">
    <xsd:import namespace="8439fbcf-6450-441b-9192-933f07ebae26"/>
    <xsd:import namespace="4a3f52a8-2511-4fc2-82a5-d1d42080630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439fbcf-6450-441b-9192-933f07ebae2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f9adb9bf-65a7-4dcd-b9fe-2cabe70ed69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a3f52a8-2511-4fc2-82a5-d1d42080630f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7630a7fd-0f13-40ca-9356-28457d157f3c}" ma:internalName="TaxCatchAll" ma:showField="CatchAllData" ma:web="4a3f52a8-2511-4fc2-82a5-d1d42080630f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C96A2CE-E041-4445-816A-C5C7D1A4559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3E0E083-35C0-4A93-8088-7A26C14612F5}">
  <ds:schemaRefs>
    <ds:schemaRef ds:uri="http://purl.org/dc/terms/"/>
    <ds:schemaRef ds:uri="8439fbcf-6450-441b-9192-933f07ebae26"/>
    <ds:schemaRef ds:uri="http://schemas.microsoft.com/office/2006/documentManagement/types"/>
    <ds:schemaRef ds:uri="http://schemas.microsoft.com/office/infopath/2007/PartnerControls"/>
    <ds:schemaRef ds:uri="4a3f52a8-2511-4fc2-82a5-d1d42080630f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8B1D514C-B81D-4725-874B-F5657E5ED5F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439fbcf-6450-441b-9192-933f07ebae26"/>
    <ds:schemaRef ds:uri="4a3f52a8-2511-4fc2-82a5-d1d42080630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7</TotalTime>
  <Words>418</Words>
  <Application>Microsoft Office PowerPoint</Application>
  <PresentationFormat>A4 210 x 297 mm</PresentationFormat>
  <Paragraphs>168</Paragraphs>
  <Slides>5</Slides>
  <Notes>4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3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rism 7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guchi Ou</dc:creator>
  <cp:lastModifiedBy>Windows User</cp:lastModifiedBy>
  <cp:revision>25</cp:revision>
  <dcterms:created xsi:type="dcterms:W3CDTF">2023-04-20T03:49:16Z</dcterms:created>
  <dcterms:modified xsi:type="dcterms:W3CDTF">2023-08-06T09:09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7D66063A5D03E42A12169524873DCDA</vt:lpwstr>
  </property>
  <property fmtid="{D5CDD505-2E9C-101B-9397-08002B2CF9AE}" pid="3" name="MediaServiceImageTags">
    <vt:lpwstr/>
  </property>
</Properties>
</file>